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6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83" d="100"/>
          <a:sy n="83" d="100"/>
        </p:scale>
        <p:origin x="800" y="-9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30/07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9512" y="5376698"/>
            <a:ext cx="7056784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leftheriadou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242-0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Pathophysiology of diabetic autonomic neuropathy: the role of hyperglycaemia and dyslipidaemi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EB59E34-F07D-4197-DDED-FA852130D02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3528" y="1422104"/>
            <a:ext cx="8513830" cy="37201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9512" y="5661248"/>
            <a:ext cx="712879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leftheriadou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4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4-06242-0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  <a:p>
            <a:endParaRPr lang="en-GB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251520" y="272842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linical presentations of cardiovascular autonomic neuropathy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79ABC43-3490-1B9A-4A83-C867895799D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79712" y="822912"/>
            <a:ext cx="5003145" cy="4838336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9512" y="5661248"/>
            <a:ext cx="705678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leftheriadou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4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4-06242-0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95536" y="332656"/>
            <a:ext cx="82089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Overview of the management of cardiovascular autonomic neuropathy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594D7BB-041A-A349-0A32-ABD03CAF600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21012" y="739370"/>
            <a:ext cx="6101977" cy="49218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7</Words>
  <Application>Microsoft Office PowerPoint</Application>
  <PresentationFormat>On-screen Show (4:3)</PresentationFormat>
  <Paragraphs>14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8</cp:revision>
  <dcterms:created xsi:type="dcterms:W3CDTF">2016-06-15T12:53:43Z</dcterms:created>
  <dcterms:modified xsi:type="dcterms:W3CDTF">2024-07-30T13:28:00Z</dcterms:modified>
</cp:coreProperties>
</file>